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61" r:id="rId4"/>
    <p:sldId id="258" r:id="rId5"/>
    <p:sldId id="262" r:id="rId6"/>
    <p:sldId id="259" r:id="rId7"/>
    <p:sldId id="263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2" autoAdjust="0"/>
    <p:restoredTop sz="94660"/>
  </p:normalViewPr>
  <p:slideViewPr>
    <p:cSldViewPr snapToGrid="0">
      <p:cViewPr varScale="1">
        <p:scale>
          <a:sx n="71" d="100"/>
          <a:sy n="71" d="100"/>
        </p:scale>
        <p:origin x="54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68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0668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859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6183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120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820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974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722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636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233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7982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9C430E-99D2-4802-AA17-EBCD3C2F65C7}" type="datetimeFigureOut">
              <a:rPr lang="en-GB" smtClean="0"/>
              <a:t>2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F1668-83E9-4EF9-BD15-17C5ED9BFF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578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jpeg"/><Relationship Id="rId4" Type="http://schemas.openxmlformats.org/officeDocument/2006/relationships/image" Target="../media/image3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7" Type="http://schemas.openxmlformats.org/officeDocument/2006/relationships/image" Target="../media/image37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1.jpeg"/><Relationship Id="rId4" Type="http://schemas.openxmlformats.org/officeDocument/2006/relationships/image" Target="../media/image4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93577" y="255494"/>
            <a:ext cx="1759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yrmecopterula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48" t="20180" r="11948" b="10502"/>
          <a:stretch/>
        </p:blipFill>
        <p:spPr>
          <a:xfrm>
            <a:off x="147918" y="1021976"/>
            <a:ext cx="3267635" cy="221876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82" t="11228"/>
          <a:stretch/>
        </p:blipFill>
        <p:spPr>
          <a:xfrm>
            <a:off x="3602024" y="1021976"/>
            <a:ext cx="3065930" cy="243894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2076" r="11765" b="7293"/>
          <a:stretch/>
        </p:blipFill>
        <p:spPr>
          <a:xfrm>
            <a:off x="425441" y="3425790"/>
            <a:ext cx="2580697" cy="239357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53" t="16836" r="784"/>
          <a:stretch/>
        </p:blipFill>
        <p:spPr>
          <a:xfrm>
            <a:off x="3334374" y="3784267"/>
            <a:ext cx="3200400" cy="20351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78" t="5619" r="6863" b="-2451"/>
          <a:stretch/>
        </p:blipFill>
        <p:spPr>
          <a:xfrm>
            <a:off x="393359" y="6004415"/>
            <a:ext cx="2776750" cy="2317491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86" t="1190" r="5490" b="2569"/>
          <a:stretch/>
        </p:blipFill>
        <p:spPr>
          <a:xfrm>
            <a:off x="3602024" y="6004415"/>
            <a:ext cx="2796988" cy="226820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69189" y="8583040"/>
            <a:ext cx="6292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1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iversity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yrmecopterul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pp.; A-B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pterostigma sp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nest cultivating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velohortorum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p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SAPV1) growing on top; C-D and F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yrmecopterula sp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(SAPX1); E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sp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PV2)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097836" y="1038543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350238" y="1020594"/>
            <a:ext cx="30970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B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688422" y="3426965"/>
            <a:ext cx="30809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18177" y="3776555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081296" y="6005557"/>
            <a:ext cx="29046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F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52393" y="5995132"/>
            <a:ext cx="29687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4496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6988" y="255494"/>
            <a:ext cx="1759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yrmecopterula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72" t="9432" r="25416" b="19260"/>
          <a:stretch/>
        </p:blipFill>
        <p:spPr>
          <a:xfrm>
            <a:off x="716724" y="922980"/>
            <a:ext cx="2273710" cy="26193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55" t="17169" r="26250" b="8178"/>
          <a:stretch/>
        </p:blipFill>
        <p:spPr>
          <a:xfrm>
            <a:off x="716724" y="3697071"/>
            <a:ext cx="2080264" cy="2700562"/>
          </a:xfrm>
          <a:prstGeom prst="rect">
            <a:avLst/>
          </a:prstGeom>
        </p:spPr>
      </p:pic>
      <p:grpSp>
        <p:nvGrpSpPr>
          <p:cNvPr id="22" name="Group 21"/>
          <p:cNvGrpSpPr/>
          <p:nvPr/>
        </p:nvGrpSpPr>
        <p:grpSpPr>
          <a:xfrm>
            <a:off x="3635628" y="926964"/>
            <a:ext cx="2966271" cy="2348720"/>
            <a:chOff x="123825" y="4458480"/>
            <a:chExt cx="2966271" cy="2348720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04" t="18686" r="17037" b="16449"/>
            <a:stretch/>
          </p:blipFill>
          <p:spPr>
            <a:xfrm>
              <a:off x="123825" y="4458480"/>
              <a:ext cx="2966271" cy="2348720"/>
            </a:xfrm>
            <a:prstGeom prst="rect">
              <a:avLst/>
            </a:prstGeom>
          </p:spPr>
        </p:pic>
        <p:sp>
          <p:nvSpPr>
            <p:cNvPr id="17" name="Oval 16"/>
            <p:cNvSpPr/>
            <p:nvPr/>
          </p:nvSpPr>
          <p:spPr>
            <a:xfrm>
              <a:off x="711200" y="5232400"/>
              <a:ext cx="584200" cy="584200"/>
            </a:xfrm>
            <a:prstGeom prst="ellipse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29" t="33704" r="34815" b="31482"/>
            <a:stretch/>
          </p:blipFill>
          <p:spPr>
            <a:xfrm>
              <a:off x="1872348" y="4458480"/>
              <a:ext cx="1217747" cy="1040620"/>
            </a:xfrm>
            <a:prstGeom prst="rect">
              <a:avLst/>
            </a:prstGeom>
          </p:spPr>
        </p:pic>
        <p:cxnSp>
          <p:nvCxnSpPr>
            <p:cNvPr id="20" name="Straight Connector 19"/>
            <p:cNvCxnSpPr>
              <a:stCxn id="17" idx="6"/>
            </p:cNvCxnSpPr>
            <p:nvPr/>
          </p:nvCxnSpPr>
          <p:spPr>
            <a:xfrm flipV="1">
              <a:off x="1295400" y="5397500"/>
              <a:ext cx="587375" cy="12700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3049893" y="3634820"/>
            <a:ext cx="3552005" cy="2359168"/>
            <a:chOff x="3225800" y="5575096"/>
            <a:chExt cx="3552005" cy="2359168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25800" y="5575096"/>
              <a:ext cx="3552005" cy="2359168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70" t="12918" r="9075" b="10687"/>
            <a:stretch/>
          </p:blipFill>
          <p:spPr>
            <a:xfrm>
              <a:off x="5067356" y="6453906"/>
              <a:ext cx="1518730" cy="1175514"/>
            </a:xfrm>
            <a:prstGeom prst="rect">
              <a:avLst/>
            </a:prstGeom>
            <a:ln w="38100">
              <a:solidFill>
                <a:srgbClr val="FF0000"/>
              </a:solidFill>
            </a:ln>
          </p:spPr>
        </p:pic>
      </p:grpSp>
      <p:pic>
        <p:nvPicPr>
          <p:cNvPr id="27" name="Picture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724" y="6552349"/>
            <a:ext cx="3325191" cy="220852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9" t="19950" r="12353" b="27108"/>
          <a:stretch/>
        </p:blipFill>
        <p:spPr>
          <a:xfrm>
            <a:off x="4203754" y="6294208"/>
            <a:ext cx="2398144" cy="246666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69189" y="8932662"/>
            <a:ext cx="629272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1 (cont.)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G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sp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PV3); H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Apterostigma 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nest cultivating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. velohortorum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 a short basidiome growing (not sequenced; probably SAPV1); I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sp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PV2); J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p.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K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Myrmecopterula sp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PX1); L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yrmecopterula moniliformi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SAPN1). Photo L kindly provided By Susanne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urell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672718" y="922980"/>
            <a:ext cx="33054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G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284183" y="922980"/>
            <a:ext cx="32893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H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244200" y="3634820"/>
            <a:ext cx="25840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J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479272" y="3697071"/>
            <a:ext cx="24237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I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724199" y="6552349"/>
            <a:ext cx="30489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K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284183" y="6294208"/>
            <a:ext cx="28245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L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6569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6988" y="255494"/>
            <a:ext cx="859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terula</a:t>
            </a:r>
            <a:endParaRPr lang="en-GB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70"/>
          <a:stretch/>
        </p:blipFill>
        <p:spPr>
          <a:xfrm>
            <a:off x="4711168" y="3930002"/>
            <a:ext cx="1803764" cy="260108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33" t="4985" r="49074" b="47763"/>
          <a:stretch/>
        </p:blipFill>
        <p:spPr>
          <a:xfrm>
            <a:off x="271642" y="1395558"/>
            <a:ext cx="2927887" cy="243750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642" y="3930002"/>
            <a:ext cx="3462158" cy="259661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8"/>
          <a:stretch/>
        </p:blipFill>
        <p:spPr>
          <a:xfrm>
            <a:off x="3494161" y="1413205"/>
            <a:ext cx="3020771" cy="2419855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642" y="6623563"/>
            <a:ext cx="3358705" cy="222646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69189" y="8919215"/>
            <a:ext cx="6292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2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iversity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terula spp.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hoto C kindly provided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y Michael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erley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880231" y="1395558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16084" y="3933507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12631" y="6623563"/>
            <a:ext cx="29687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197216" y="3933507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97216" y="1411100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B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6076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6988" y="255494"/>
            <a:ext cx="1259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terulicium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48" t="2667" r="12548" b="7587"/>
          <a:stretch/>
        </p:blipFill>
        <p:spPr>
          <a:xfrm>
            <a:off x="143591" y="1331259"/>
            <a:ext cx="2347485" cy="233978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5" t="31598" r="33726" b="24414"/>
          <a:stretch/>
        </p:blipFill>
        <p:spPr>
          <a:xfrm>
            <a:off x="195272" y="3822882"/>
            <a:ext cx="2366682" cy="20036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85" t="25103" r="36666" b="28252"/>
          <a:stretch/>
        </p:blipFill>
        <p:spPr>
          <a:xfrm>
            <a:off x="2561954" y="1331259"/>
            <a:ext cx="2133317" cy="203050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1" t="4872" r="16179" b="12023"/>
          <a:stretch/>
        </p:blipFill>
        <p:spPr>
          <a:xfrm>
            <a:off x="3845859" y="5878046"/>
            <a:ext cx="2683395" cy="2081215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29" t="36199" r="38055" b="17797"/>
          <a:stretch/>
        </p:blipFill>
        <p:spPr>
          <a:xfrm>
            <a:off x="340646" y="5966555"/>
            <a:ext cx="3287966" cy="1992706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22" t="19888" r="35000" b="26858"/>
          <a:stretch/>
        </p:blipFill>
        <p:spPr>
          <a:xfrm>
            <a:off x="4766149" y="1331259"/>
            <a:ext cx="1993826" cy="2151529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37" t="21481" r="35185" b="15610"/>
          <a:stretch/>
        </p:blipFill>
        <p:spPr>
          <a:xfrm>
            <a:off x="2724641" y="3531692"/>
            <a:ext cx="1960879" cy="1909947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97" t="4426" r="28148" b="21481"/>
          <a:stretch/>
        </p:blipFill>
        <p:spPr>
          <a:xfrm>
            <a:off x="4868890" y="3586419"/>
            <a:ext cx="1804795" cy="218388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69189" y="8179630"/>
            <a:ext cx="62927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3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iversity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terulicium spp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: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Pterulicium cf.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simplex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F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terulicium cf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rucei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G and H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terulicium cf.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unneosetosu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the remaining are not identified.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73360" y="1331259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44238" y="3822882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376570" y="1331259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B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42259" y="1331399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55969" y="3586419"/>
            <a:ext cx="29046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F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61987" y="3526434"/>
            <a:ext cx="29687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10896" y="5966555"/>
            <a:ext cx="33054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G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211538" y="5873935"/>
            <a:ext cx="32893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H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60001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6988" y="255494"/>
            <a:ext cx="1259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terulicium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95" t="13846" r="31418" b="6282"/>
          <a:stretch/>
        </p:blipFill>
        <p:spPr>
          <a:xfrm>
            <a:off x="114065" y="1254000"/>
            <a:ext cx="1585690" cy="484257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40" t="27137" r="3519" b="20166"/>
          <a:stretch/>
        </p:blipFill>
        <p:spPr>
          <a:xfrm>
            <a:off x="2034066" y="3176474"/>
            <a:ext cx="4650528" cy="292009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18" t="30556" r="29444" b="21666"/>
          <a:stretch/>
        </p:blipFill>
        <p:spPr>
          <a:xfrm>
            <a:off x="4014778" y="1254001"/>
            <a:ext cx="2669816" cy="180790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8" t="17009" r="16111" b="10297"/>
          <a:stretch/>
        </p:blipFill>
        <p:spPr>
          <a:xfrm>
            <a:off x="1820778" y="1254001"/>
            <a:ext cx="2106906" cy="180790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69189" y="6323940"/>
            <a:ext cx="62927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3 (cont.)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 and K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terulicium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undirameu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L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terulicium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laceobrunneum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J is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ot identified.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82039" y="1254000"/>
            <a:ext cx="24237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I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09968" y="1254000"/>
            <a:ext cx="25840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J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365506" y="1254000"/>
            <a:ext cx="30489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K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365506" y="3176474"/>
            <a:ext cx="28245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L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9671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96988" y="255494"/>
            <a:ext cx="14491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haeopterula</a:t>
            </a:r>
            <a:endParaRPr lang="en-GB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50" t="20097" r="34722" b="19887"/>
          <a:stretch/>
        </p:blipFill>
        <p:spPr>
          <a:xfrm>
            <a:off x="3181602" y="979659"/>
            <a:ext cx="1839080" cy="215435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6" t="8805" r="30278" b="18633"/>
          <a:stretch/>
        </p:blipFill>
        <p:spPr>
          <a:xfrm>
            <a:off x="139407" y="979660"/>
            <a:ext cx="2956276" cy="2168769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72" t="16123" r="32500" b="16751"/>
          <a:stretch/>
        </p:blipFill>
        <p:spPr>
          <a:xfrm>
            <a:off x="139408" y="3284640"/>
            <a:ext cx="1947318" cy="2551384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07" t="20445" r="45556" b="25185"/>
          <a:stretch/>
        </p:blipFill>
        <p:spPr>
          <a:xfrm>
            <a:off x="2204337" y="3284640"/>
            <a:ext cx="2616804" cy="2551384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63" t="23718" r="36852" b="25396"/>
          <a:stretch/>
        </p:blipFill>
        <p:spPr>
          <a:xfrm>
            <a:off x="5126254" y="979659"/>
            <a:ext cx="1609845" cy="2154351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93" t="22040" r="30237" b="11416"/>
          <a:stretch/>
        </p:blipFill>
        <p:spPr>
          <a:xfrm>
            <a:off x="4938752" y="3605450"/>
            <a:ext cx="1815353" cy="2230574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69189" y="6041551"/>
            <a:ext cx="62927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4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iversity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aeopterula spp.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, E and F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aeopterula cf. juruensis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D: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haeopterula </a:t>
            </a:r>
            <a:r>
              <a:rPr lang="en-GB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ipata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A and B ar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ot identified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777967" y="979659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A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02966" y="979659"/>
            <a:ext cx="30970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418383" y="979659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36389" y="3605450"/>
            <a:ext cx="29046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F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03425" y="3284640"/>
            <a:ext cx="29687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68134" y="3284640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2642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15" y="814595"/>
            <a:ext cx="3127637" cy="2345728"/>
          </a:xfrm>
          <a:prstGeom prst="rect">
            <a:avLst/>
          </a:prstGeom>
        </p:spPr>
      </p:pic>
      <p:grpSp>
        <p:nvGrpSpPr>
          <p:cNvPr id="57" name="Group 56"/>
          <p:cNvGrpSpPr/>
          <p:nvPr/>
        </p:nvGrpSpPr>
        <p:grpSpPr>
          <a:xfrm>
            <a:off x="3529539" y="814594"/>
            <a:ext cx="3127639" cy="2345729"/>
            <a:chOff x="3529539" y="814594"/>
            <a:chExt cx="3127639" cy="234572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9539" y="814594"/>
              <a:ext cx="3127639" cy="2345729"/>
            </a:xfrm>
            <a:prstGeom prst="rect">
              <a:avLst/>
            </a:prstGeom>
            <a:ln>
              <a:noFill/>
            </a:ln>
          </p:spPr>
        </p:pic>
        <p:cxnSp>
          <p:nvCxnSpPr>
            <p:cNvPr id="45" name="Straight Connector 44"/>
            <p:cNvCxnSpPr/>
            <p:nvPr/>
          </p:nvCxnSpPr>
          <p:spPr>
            <a:xfrm>
              <a:off x="6184085" y="3002878"/>
              <a:ext cx="32557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oup 55"/>
          <p:cNvGrpSpPr/>
          <p:nvPr/>
        </p:nvGrpSpPr>
        <p:grpSpPr>
          <a:xfrm>
            <a:off x="3529540" y="3325389"/>
            <a:ext cx="3127638" cy="2345728"/>
            <a:chOff x="3529540" y="3325389"/>
            <a:chExt cx="3127638" cy="2345728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9540" y="3325389"/>
              <a:ext cx="3127638" cy="2345728"/>
            </a:xfrm>
            <a:prstGeom prst="rect">
              <a:avLst/>
            </a:prstGeom>
          </p:spPr>
        </p:pic>
        <p:cxnSp>
          <p:nvCxnSpPr>
            <p:cNvPr id="48" name="Straight Connector 47"/>
            <p:cNvCxnSpPr/>
            <p:nvPr/>
          </p:nvCxnSpPr>
          <p:spPr>
            <a:xfrm>
              <a:off x="6366628" y="5533353"/>
              <a:ext cx="143027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Group 54"/>
          <p:cNvGrpSpPr/>
          <p:nvPr/>
        </p:nvGrpSpPr>
        <p:grpSpPr>
          <a:xfrm>
            <a:off x="204315" y="3325388"/>
            <a:ext cx="3127637" cy="2345728"/>
            <a:chOff x="204315" y="3325388"/>
            <a:chExt cx="3127637" cy="2345728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4315" y="3325388"/>
              <a:ext cx="3127637" cy="2345728"/>
            </a:xfrm>
            <a:prstGeom prst="rect">
              <a:avLst/>
            </a:prstGeom>
          </p:spPr>
        </p:pic>
        <p:cxnSp>
          <p:nvCxnSpPr>
            <p:cNvPr id="51" name="Straight Connector 50"/>
            <p:cNvCxnSpPr/>
            <p:nvPr/>
          </p:nvCxnSpPr>
          <p:spPr>
            <a:xfrm>
              <a:off x="2936825" y="5533353"/>
              <a:ext cx="281475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/>
          <p:cNvSpPr txBox="1"/>
          <p:nvPr/>
        </p:nvSpPr>
        <p:spPr>
          <a:xfrm>
            <a:off x="0" y="330264"/>
            <a:ext cx="6857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Microscopic features of </a:t>
            </a:r>
            <a:r>
              <a:rPr lang="en-GB" i="1" dirty="0" smtClean="0"/>
              <a:t>M. velohortorum</a:t>
            </a:r>
            <a:endParaRPr lang="en-GB" i="1" dirty="0"/>
          </a:p>
        </p:txBody>
      </p:sp>
      <p:sp>
        <p:nvSpPr>
          <p:cNvPr id="9" name="TextBox 8"/>
          <p:cNvSpPr txBox="1"/>
          <p:nvPr/>
        </p:nvSpPr>
        <p:spPr>
          <a:xfrm>
            <a:off x="269189" y="6041551"/>
            <a:ext cx="6292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: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croscopic details of 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velohortorum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: Gold and platinum coated clamp connection at 5kV SEM; B-D Racquet hypha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under light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croscope. Scale bars in B-D = 15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014236" y="813492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6339462" y="813492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3014236" y="3325387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sp>
        <p:nvSpPr>
          <p:cNvPr id="24" name="TextBox 23"/>
          <p:cNvSpPr txBox="1"/>
          <p:nvPr/>
        </p:nvSpPr>
        <p:spPr>
          <a:xfrm>
            <a:off x="6339462" y="3325387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72955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218</TotalTime>
  <Words>320</Words>
  <Application>Microsoft Office PowerPoint</Application>
  <PresentationFormat>A4 Paper (210x297 mm)</PresentationFormat>
  <Paragraphs>5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io Ambrosio Leal Dutra [caa22]</dc:creator>
  <cp:lastModifiedBy>Caio Ambrosio Leal Dutra [caa22]</cp:lastModifiedBy>
  <cp:revision>35</cp:revision>
  <dcterms:created xsi:type="dcterms:W3CDTF">2019-01-22T17:29:35Z</dcterms:created>
  <dcterms:modified xsi:type="dcterms:W3CDTF">2019-05-22T10:07:18Z</dcterms:modified>
</cp:coreProperties>
</file>